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embeddings/oleObject1.bin" ContentType="application/vnd.openxmlformats-officedocument.oleObje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8F4616-7418-4B0B-A639-05B474D6A9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A02C2A-C718-4229-8527-4D511168076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A13030-D36B-4B54-A8A6-B8F5D711FDB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B8DE89E-F016-4B10-9E20-5AB720F1834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22A6A3-DBD3-47DD-9641-AF14C0AE603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1C1085-4427-4DDB-9A0A-C47C77B477D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F3BF62-6A06-4A85-9293-62795C6FE8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AD2232-DFBF-4428-8E7A-1936A1F5B4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AD8654-F580-4B26-938A-D35F8D1A5FF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D45C8F-21DF-4B0C-A475-6C3494B78B9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AC4C6E-8211-417A-AC1B-CEB69F08FA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0BDCE-2A4F-4F6C-BD57-64544F62C4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443D9E5-DBA0-4529-8047-937E72A8CB7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Supplemental Figure 2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" descr=""/>
          <p:cNvPicPr/>
          <p:nvPr/>
        </p:nvPicPr>
        <p:blipFill>
          <a:blip r:embed="rId1"/>
          <a:srcRect l="2137" t="9445" r="2405" b="0"/>
          <a:stretch/>
        </p:blipFill>
        <p:spPr>
          <a:xfrm>
            <a:off x="5460840" y="2379600"/>
            <a:ext cx="3402000" cy="2739960"/>
          </a:xfrm>
          <a:prstGeom prst="rect">
            <a:avLst/>
          </a:prstGeom>
          <a:ln w="0">
            <a:noFill/>
          </a:ln>
        </p:spPr>
      </p:pic>
      <p:grpSp>
        <p:nvGrpSpPr>
          <p:cNvPr id="43" name=""/>
          <p:cNvGrpSpPr/>
          <p:nvPr/>
        </p:nvGrpSpPr>
        <p:grpSpPr>
          <a:xfrm>
            <a:off x="431640" y="2136600"/>
            <a:ext cx="4326840" cy="2917800"/>
            <a:chOff x="431640" y="2136600"/>
            <a:chExt cx="4326840" cy="2917800"/>
          </a:xfrm>
        </p:grpSpPr>
        <p:graphicFrame>
          <p:nvGraphicFramePr>
            <p:cNvPr id="44" name=""/>
            <p:cNvGraphicFramePr/>
            <p:nvPr/>
          </p:nvGraphicFramePr>
          <p:xfrm>
            <a:off x="431640" y="2136600"/>
            <a:ext cx="3524400" cy="2917800"/>
          </p:xfrm>
          <a:graphic>
            <a:graphicData uri="http://schemas.openxmlformats.org/presentationml/2006/ole">
              <p:oleObj r:id="rId2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431640" y="2136600"/>
                      <a:ext cx="3524400" cy="29178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pSp>
          <p:nvGrpSpPr>
            <p:cNvPr id="46" name=""/>
            <p:cNvGrpSpPr/>
            <p:nvPr/>
          </p:nvGrpSpPr>
          <p:grpSpPr>
            <a:xfrm>
              <a:off x="2806560" y="2633400"/>
              <a:ext cx="1951920" cy="855720"/>
              <a:chOff x="2806560" y="2633400"/>
              <a:chExt cx="1951920" cy="855720"/>
            </a:xfrm>
          </p:grpSpPr>
          <p:sp>
            <p:nvSpPr>
              <p:cNvPr id="47" name=""/>
              <p:cNvSpPr/>
              <p:nvPr/>
            </p:nvSpPr>
            <p:spPr>
              <a:xfrm>
                <a:off x="2806560" y="2709360"/>
                <a:ext cx="1857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806560" y="2890440"/>
                <a:ext cx="1857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806560" y="3052440"/>
                <a:ext cx="185760" cy="0"/>
              </a:xfrm>
              <a:prstGeom prst="line">
                <a:avLst/>
              </a:prstGeom>
              <a:ln w="1908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806560" y="3233520"/>
                <a:ext cx="18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806560" y="3409560"/>
                <a:ext cx="18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sysDot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098880" y="2633400"/>
                <a:ext cx="512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K-177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2868480" y="2674440"/>
                <a:ext cx="61920" cy="61920"/>
              </a:xfrm>
              <a:prstGeom prst="rect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099600" y="2809440"/>
                <a:ext cx="1658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K-1775 + 37.5 nM MK-877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2868480" y="2850840"/>
                <a:ext cx="61920" cy="61920"/>
              </a:xfrm>
              <a:custGeom>
                <a:avLst/>
                <a:gdLst/>
                <a:ahLst/>
                <a:rect l="l" t="t" r="r" b="b"/>
                <a:pathLst>
                  <a:path w="39" h="39">
                    <a:moveTo>
                      <a:pt x="0" y="39"/>
                    </a:moveTo>
                    <a:lnTo>
                      <a:pt x="39" y="39"/>
                    </a:lnTo>
                    <a:lnTo>
                      <a:pt x="19" y="0"/>
                    </a:lnTo>
                    <a:lnTo>
                      <a:pt x="0" y="39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3099600" y="2984040"/>
                <a:ext cx="1553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K-1775 + 75 nM MK-877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2868480" y="3026880"/>
                <a:ext cx="61920" cy="60480"/>
              </a:xfrm>
              <a:custGeom>
                <a:avLst/>
                <a:gdLst/>
                <a:ahLst/>
                <a:rect l="l" t="t" r="r" b="b"/>
                <a:pathLst>
                  <a:path w="39" h="38">
                    <a:moveTo>
                      <a:pt x="19" y="38"/>
                    </a:moveTo>
                    <a:lnTo>
                      <a:pt x="39" y="0"/>
                    </a:lnTo>
                    <a:lnTo>
                      <a:pt x="0" y="0"/>
                    </a:lnTo>
                    <a:lnTo>
                      <a:pt x="19" y="38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680" bIns="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>
                <a:off x="3099600" y="3160440"/>
                <a:ext cx="1623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K-1775 + 150 nM MK-877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>
                <a:off x="2860560" y="3195360"/>
                <a:ext cx="76320" cy="75960"/>
              </a:xfrm>
              <a:custGeom>
                <a:avLst/>
                <a:gdLst/>
                <a:ahLst/>
                <a:rect l="l" t="t" r="r" b="b"/>
                <a:pathLst>
                  <a:path w="48" h="48">
                    <a:moveTo>
                      <a:pt x="0" y="24"/>
                    </a:moveTo>
                    <a:lnTo>
                      <a:pt x="24" y="48"/>
                    </a:lnTo>
                    <a:lnTo>
                      <a:pt x="48" y="24"/>
                    </a:lnTo>
                    <a:lnTo>
                      <a:pt x="24" y="0"/>
                    </a:lnTo>
                    <a:lnTo>
                      <a:pt x="0" y="24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3099600" y="3336480"/>
                <a:ext cx="1623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 algn="ctr"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MK-1775 + 300 nM MK-877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2868480" y="3377880"/>
                <a:ext cx="61920" cy="60120"/>
              </a:xfrm>
              <a:prstGeom prst="ellipse">
                <a:avLst/>
              </a:pr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" bIns="-3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2" name=""/>
          <p:cNvSpPr/>
          <p:nvPr/>
        </p:nvSpPr>
        <p:spPr>
          <a:xfrm>
            <a:off x="436320" y="201924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132160" y="2019240"/>
            <a:ext cx="397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484960" y="4819680"/>
            <a:ext cx="83484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K-8776 (</a:t>
            </a:r>
            <a:r>
              <a:rPr b="0" lang="el-GR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623000" y="4876920"/>
            <a:ext cx="835200" cy="1526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K-1775 (</a:t>
            </a:r>
            <a:r>
              <a:rPr b="0" lang="el-GR" sz="1000" spc="-1" strike="noStrike">
                <a:solidFill>
                  <a:srgbClr val="000000"/>
                </a:solidFill>
                <a:latin typeface="Arial Unicode MS"/>
                <a:ea typeface="Arial Unicode MS"/>
              </a:rPr>
              <a:t>μ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956280" y="4743360"/>
            <a:ext cx="135000" cy="136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 rot="10800000">
            <a:off x="5357880" y="2862000"/>
            <a:ext cx="95040" cy="1299960"/>
          </a:xfrm>
          <a:prstGeom prst="rtTriangl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 rot="16200000">
            <a:off x="4746240" y="3342960"/>
            <a:ext cx="835200" cy="3049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fractional prolifer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5824080" y="2509920"/>
            <a:ext cx="502200" cy="459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R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el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 rot="1463400">
            <a:off x="5239800" y="4502160"/>
            <a:ext cx="1845000" cy="184320"/>
          </a:xfrm>
          <a:prstGeom prst="parallelogram">
            <a:avLst>
              <a:gd name="adj" fmla="val 250244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 flipV="1" rot="20688000">
            <a:off x="6987960" y="4572360"/>
            <a:ext cx="2349360" cy="184320"/>
          </a:xfrm>
          <a:prstGeom prst="parallelogram">
            <a:avLst>
              <a:gd name="adj" fmla="val 318652"/>
            </a:avLst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 flipH="1" rot="17640600">
            <a:off x="6097320" y="3798720"/>
            <a:ext cx="168120" cy="1618920"/>
          </a:xfrm>
          <a:prstGeom prst="rtTriangl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 flipH="1" rot="4107000">
            <a:off x="7855200" y="3758760"/>
            <a:ext cx="168480" cy="1728720"/>
          </a:xfrm>
          <a:prstGeom prst="rtTriangle">
            <a:avLst/>
          </a:prstGeom>
          <a:solidFill>
            <a:srgbClr val="00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2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26T13:05:12Z</dcterms:created>
  <dc:creator>Shumway</dc:creator>
  <dc:description/>
  <dc:language>en-US</dc:language>
  <cp:lastModifiedBy>Shumway</cp:lastModifiedBy>
  <dcterms:modified xsi:type="dcterms:W3CDTF">2012-10-26T12:31:58Z</dcterms:modified>
  <cp:revision>195</cp:revision>
  <dc:subject/>
  <dc:title>Draft figures for Wee + CHK manuscript</dc:title>
</cp:coreProperties>
</file>